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>
        <p:scale>
          <a:sx n="300" d="100"/>
          <a:sy n="300" d="100"/>
        </p:scale>
        <p:origin x="2706" y="-103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1%20membran\aquaporine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27713</a:t>
            </a:r>
          </a:p>
        </c:rich>
      </c:tx>
      <c:layout>
        <c:manualLayout>
          <c:xMode val="edge"/>
          <c:yMode val="edge"/>
          <c:x val="0.31034103285102249"/>
          <c:y val="0.1578989709872525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1814490575775167"/>
          <c:y val="0.28477543826289192"/>
          <c:w val="0.5397005194992468"/>
          <c:h val="0.432288474618416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F$24</c:f>
              <c:strCache>
                <c:ptCount val="1"/>
                <c:pt idx="0">
                  <c:v>Unigene002771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F$25:$F$30</c:f>
              <c:numCache>
                <c:formatCode>General</c:formatCode>
                <c:ptCount val="6"/>
                <c:pt idx="0">
                  <c:v>0</c:v>
                </c:pt>
                <c:pt idx="1">
                  <c:v>4.5233333000000001E-2</c:v>
                </c:pt>
                <c:pt idx="2">
                  <c:v>0.100766667</c:v>
                </c:pt>
                <c:pt idx="3">
                  <c:v>0.290566667</c:v>
                </c:pt>
                <c:pt idx="4">
                  <c:v>0.21340000000000001</c:v>
                </c:pt>
                <c:pt idx="5">
                  <c:v>0.4559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EB-417E-8114-1ED3957A00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05414</a:t>
            </a:r>
          </a:p>
        </c:rich>
      </c:tx>
      <c:layout>
        <c:manualLayout>
          <c:xMode val="edge"/>
          <c:yMode val="edge"/>
          <c:x val="0.3004221246537731"/>
          <c:y val="0.151515151515151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0189532760017901"/>
          <c:y val="0.28087121212121213"/>
          <c:w val="0.52145336671625719"/>
          <c:h val="0.449602570985444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B$24</c:f>
              <c:strCache>
                <c:ptCount val="1"/>
                <c:pt idx="0">
                  <c:v>Unigene000541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B$25:$B$30</c:f>
              <c:numCache>
                <c:formatCode>General</c:formatCode>
                <c:ptCount val="6"/>
                <c:pt idx="0">
                  <c:v>0.431433333333333</c:v>
                </c:pt>
                <c:pt idx="1">
                  <c:v>1.4101999999999999</c:v>
                </c:pt>
                <c:pt idx="2">
                  <c:v>0.57730000000000004</c:v>
                </c:pt>
                <c:pt idx="3">
                  <c:v>3.6400000000000002E-2</c:v>
                </c:pt>
                <c:pt idx="4">
                  <c:v>9.0666666666666701E-2</c:v>
                </c:pt>
                <c:pt idx="5">
                  <c:v>7.53999999999999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7E-4726-B84C-9F77138F2F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09897</a:t>
            </a:r>
          </a:p>
        </c:rich>
      </c:tx>
      <c:layout>
        <c:manualLayout>
          <c:xMode val="edge"/>
          <c:yMode val="edge"/>
          <c:x val="0.33321439296714156"/>
          <c:y val="0.1382499515580878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2803621569868263"/>
          <c:y val="0.2733662375475257"/>
          <c:w val="0.55512623121350058"/>
          <c:h val="0.427442724242510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C$24</c:f>
              <c:strCache>
                <c:ptCount val="1"/>
                <c:pt idx="0">
                  <c:v>Unigene000989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C$25:$C$30</c:f>
              <c:numCache>
                <c:formatCode>General</c:formatCode>
                <c:ptCount val="6"/>
                <c:pt idx="0">
                  <c:v>1.07896666666667</c:v>
                </c:pt>
                <c:pt idx="1">
                  <c:v>1.5743</c:v>
                </c:pt>
                <c:pt idx="2">
                  <c:v>0.1895</c:v>
                </c:pt>
                <c:pt idx="3">
                  <c:v>4.91333333333333E-2</c:v>
                </c:pt>
                <c:pt idx="4">
                  <c:v>0.17199999999999999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B3-4880-8AB1-EF26C83904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31574</a:t>
            </a:r>
          </a:p>
        </c:rich>
      </c:tx>
      <c:layout>
        <c:manualLayout>
          <c:xMode val="edge"/>
          <c:yMode val="edge"/>
          <c:x val="0.30541289191448234"/>
          <c:y val="0.1367521367521367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0612731736004772"/>
          <c:y val="0.25350427350427351"/>
          <c:w val="0.52253322384942247"/>
          <c:h val="0.400666935863786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I$24</c:f>
              <c:strCache>
                <c:ptCount val="1"/>
                <c:pt idx="0">
                  <c:v>Unigene003157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I$25:$I$30</c:f>
              <c:numCache>
                <c:formatCode>General</c:formatCode>
                <c:ptCount val="6"/>
                <c:pt idx="0">
                  <c:v>0.2331</c:v>
                </c:pt>
                <c:pt idx="1">
                  <c:v>0.76100000000000001</c:v>
                </c:pt>
                <c:pt idx="2">
                  <c:v>9.7100000000000006E-2</c:v>
                </c:pt>
                <c:pt idx="3">
                  <c:v>0</c:v>
                </c:pt>
                <c:pt idx="4">
                  <c:v>0.25790000000000002</c:v>
                </c:pt>
                <c:pt idx="5">
                  <c:v>0.17953333333333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3C-48BE-951A-738F22237C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31575</a:t>
            </a:r>
          </a:p>
        </c:rich>
      </c:tx>
      <c:layout>
        <c:manualLayout>
          <c:xMode val="edge"/>
          <c:yMode val="edge"/>
          <c:x val="0.30831151508268378"/>
          <c:y val="0.130568356374807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0156668531336728"/>
          <c:y val="0.22780337941628265"/>
          <c:w val="0.52964644164166674"/>
          <c:h val="0.353901931613387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J$24</c:f>
              <c:strCache>
                <c:ptCount val="1"/>
                <c:pt idx="0">
                  <c:v>Unigene003157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J$25:$J$30</c:f>
              <c:numCache>
                <c:formatCode>General</c:formatCode>
                <c:ptCount val="6"/>
                <c:pt idx="0">
                  <c:v>0.28413333333333302</c:v>
                </c:pt>
                <c:pt idx="1">
                  <c:v>1.0315333333333301</c:v>
                </c:pt>
                <c:pt idx="2">
                  <c:v>0.10566666666666701</c:v>
                </c:pt>
                <c:pt idx="3">
                  <c:v>0</c:v>
                </c:pt>
                <c:pt idx="4">
                  <c:v>4.8000000000000001E-2</c:v>
                </c:pt>
                <c:pt idx="5">
                  <c:v>0.273966666666667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E1-4C26-A6FA-A484D25AF2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65810</a:t>
            </a:r>
          </a:p>
        </c:rich>
      </c:tx>
      <c:layout>
        <c:manualLayout>
          <c:xMode val="edge"/>
          <c:yMode val="edge"/>
          <c:x val="0.27446275141235094"/>
          <c:y val="0.124635737948454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7716558166650473"/>
          <c:y val="0.2310434992219467"/>
          <c:w val="0.47603736657274126"/>
          <c:h val="0.368081474480035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N$24</c:f>
              <c:strCache>
                <c:ptCount val="1"/>
                <c:pt idx="0">
                  <c:v>Unigene006581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N$25:$N$30</c:f>
              <c:numCache>
                <c:formatCode>General</c:formatCode>
                <c:ptCount val="6"/>
                <c:pt idx="0">
                  <c:v>0.34320000000000001</c:v>
                </c:pt>
                <c:pt idx="1">
                  <c:v>0.40276666666666666</c:v>
                </c:pt>
                <c:pt idx="2">
                  <c:v>0.15306666666666666</c:v>
                </c:pt>
                <c:pt idx="3">
                  <c:v>0.13396666666666668</c:v>
                </c:pt>
                <c:pt idx="4">
                  <c:v>0.41683333333333333</c:v>
                </c:pt>
                <c:pt idx="5">
                  <c:v>0.2197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9C-4A7F-9F1E-52C0142F72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79278</a:t>
            </a:r>
          </a:p>
        </c:rich>
      </c:tx>
      <c:layout>
        <c:manualLayout>
          <c:xMode val="edge"/>
          <c:yMode val="edge"/>
          <c:x val="0.25806689209548361"/>
          <c:y val="0.129969418960244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5712070914789453"/>
          <c:y val="0.22675840978593273"/>
          <c:w val="0.44197560115066559"/>
          <c:h val="0.364510944159503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P$24</c:f>
              <c:strCache>
                <c:ptCount val="1"/>
                <c:pt idx="0">
                  <c:v>Unigene0079278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P$25:$P$30</c:f>
              <c:numCache>
                <c:formatCode>General</c:formatCode>
                <c:ptCount val="6"/>
                <c:pt idx="0">
                  <c:v>0</c:v>
                </c:pt>
                <c:pt idx="1">
                  <c:v>1.2813666666666668</c:v>
                </c:pt>
                <c:pt idx="2">
                  <c:v>0</c:v>
                </c:pt>
                <c:pt idx="3">
                  <c:v>0.13546666666666665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D8-42B0-A093-03B9F04052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82843</a:t>
            </a:r>
          </a:p>
        </c:rich>
      </c:tx>
      <c:layout>
        <c:manualLayout>
          <c:xMode val="edge"/>
          <c:yMode val="edge"/>
          <c:x val="0.24416455727310707"/>
          <c:y val="0.13816925734024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4535941608709544"/>
          <c:y val="0.25613126079447324"/>
          <c:w val="0.42380575557248534"/>
          <c:h val="0.403091809119714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Q$24</c:f>
              <c:strCache>
                <c:ptCount val="1"/>
                <c:pt idx="0">
                  <c:v>Unigene008284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Q$25:$Q$30</c:f>
              <c:numCache>
                <c:formatCode>General</c:formatCode>
                <c:ptCount val="6"/>
                <c:pt idx="0">
                  <c:v>0.11046666666666666</c:v>
                </c:pt>
                <c:pt idx="1">
                  <c:v>0.90413333333333323</c:v>
                </c:pt>
                <c:pt idx="2">
                  <c:v>0</c:v>
                </c:pt>
                <c:pt idx="3">
                  <c:v>0.40056666666666668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C2-4128-A6BE-2F4C4BF3C8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29156</a:t>
            </a:r>
          </a:p>
        </c:rich>
      </c:tx>
      <c:layout>
        <c:manualLayout>
          <c:xMode val="edge"/>
          <c:yMode val="edge"/>
          <c:x val="0.25554164010928593"/>
          <c:y val="0.1578990864671194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5392294251844544"/>
          <c:y val="0.27548746497733906"/>
          <c:w val="0.53570057438489382"/>
          <c:h val="0.441576240977848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H$24</c:f>
              <c:strCache>
                <c:ptCount val="1"/>
                <c:pt idx="0">
                  <c:v>Unigene002915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H$25:$H$30</c:f>
              <c:numCache>
                <c:formatCode>General</c:formatCode>
                <c:ptCount val="6"/>
                <c:pt idx="0">
                  <c:v>0</c:v>
                </c:pt>
                <c:pt idx="1">
                  <c:v>1.9255000000000002</c:v>
                </c:pt>
                <c:pt idx="2">
                  <c:v>2.58E-2</c:v>
                </c:pt>
                <c:pt idx="3">
                  <c:v>1.6999999999999998E-2</c:v>
                </c:pt>
                <c:pt idx="4">
                  <c:v>4.0500000000000001E-2</c:v>
                </c:pt>
                <c:pt idx="5">
                  <c:v>1.406666666666666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E7-4125-A2A0-FC9001FDBD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24093</a:t>
            </a:r>
          </a:p>
        </c:rich>
      </c:tx>
      <c:layout>
        <c:manualLayout>
          <c:xMode val="edge"/>
          <c:yMode val="edge"/>
          <c:x val="0.28799031719671986"/>
          <c:y val="0.125353244075142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9582035866461948"/>
          <c:y val="0.24742801868985739"/>
          <c:w val="0.58926943277091592"/>
          <c:h val="0.468483263709514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D$24</c:f>
              <c:strCache>
                <c:ptCount val="1"/>
                <c:pt idx="0">
                  <c:v>Unigene002409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D$25:$D$30</c:f>
              <c:numCache>
                <c:formatCode>General</c:formatCode>
                <c:ptCount val="6"/>
                <c:pt idx="0">
                  <c:v>2.3400000000000001E-2</c:v>
                </c:pt>
                <c:pt idx="1">
                  <c:v>0.41589999999999999</c:v>
                </c:pt>
                <c:pt idx="2">
                  <c:v>0.62046666699999997</c:v>
                </c:pt>
                <c:pt idx="3">
                  <c:v>0.276433333</c:v>
                </c:pt>
                <c:pt idx="4">
                  <c:v>7.2874333330000001</c:v>
                </c:pt>
                <c:pt idx="5">
                  <c:v>7.310533333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C1-4763-8ADF-84F6C8A20C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24094</a:t>
            </a:r>
          </a:p>
        </c:rich>
      </c:tx>
      <c:layout>
        <c:manualLayout>
          <c:xMode val="edge"/>
          <c:yMode val="edge"/>
          <c:x val="0.2570490451580606"/>
          <c:y val="0.1287657749773236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5484120323335829"/>
          <c:y val="0.25339482269553326"/>
          <c:w val="0.63296302840231455"/>
          <c:h val="0.475917836360615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E$24</c:f>
              <c:strCache>
                <c:ptCount val="1"/>
                <c:pt idx="0">
                  <c:v>Unigene002409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E$25:$E$30</c:f>
              <c:numCache>
                <c:formatCode>General</c:formatCode>
                <c:ptCount val="6"/>
                <c:pt idx="0">
                  <c:v>13.87443333</c:v>
                </c:pt>
                <c:pt idx="1">
                  <c:v>30.029399999999999</c:v>
                </c:pt>
                <c:pt idx="2">
                  <c:v>30.83786667</c:v>
                </c:pt>
                <c:pt idx="3">
                  <c:v>29.678766670000002</c:v>
                </c:pt>
                <c:pt idx="4">
                  <c:v>160.27889999999999</c:v>
                </c:pt>
                <c:pt idx="5">
                  <c:v>174.6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DF-48DF-B28F-79964F33FF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28734</a:t>
            </a:r>
          </a:p>
        </c:rich>
      </c:tx>
      <c:layout>
        <c:manualLayout>
          <c:xMode val="edge"/>
          <c:yMode val="edge"/>
          <c:x val="0.33432685724067107"/>
          <c:y val="3.378375382727368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3597084331849825"/>
          <c:y val="0.17601166151699391"/>
          <c:w val="0.60537986420175738"/>
          <c:h val="0.4950612977175321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G$24</c:f>
              <c:strCache>
                <c:ptCount val="1"/>
                <c:pt idx="0">
                  <c:v>Unigene002873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G$25:$G$30</c:f>
              <c:numCache>
                <c:formatCode>General</c:formatCode>
                <c:ptCount val="6"/>
                <c:pt idx="0">
                  <c:v>0</c:v>
                </c:pt>
                <c:pt idx="1">
                  <c:v>0.3039</c:v>
                </c:pt>
                <c:pt idx="2">
                  <c:v>0.44</c:v>
                </c:pt>
                <c:pt idx="3">
                  <c:v>0.52796666699999995</c:v>
                </c:pt>
                <c:pt idx="4">
                  <c:v>0.192</c:v>
                </c:pt>
                <c:pt idx="5">
                  <c:v>0.934133333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69-4E10-86E2-DA1432C763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8.4110036517174469E-2"/>
              <c:y val="0.2873783182165520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45075</a:t>
            </a:r>
          </a:p>
        </c:rich>
      </c:tx>
      <c:layout>
        <c:manualLayout>
          <c:xMode val="edge"/>
          <c:yMode val="edge"/>
          <c:x val="0.30582085506028672"/>
          <c:y val="0.148893163121115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054855037032459"/>
          <c:y val="0.26853319889961125"/>
          <c:w val="0.53130608950331881"/>
          <c:h val="0.403359095965402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K$24</c:f>
              <c:strCache>
                <c:ptCount val="1"/>
                <c:pt idx="0">
                  <c:v>Unigene004507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K$25:$K$30</c:f>
              <c:numCache>
                <c:formatCode>General</c:formatCode>
                <c:ptCount val="6"/>
                <c:pt idx="0">
                  <c:v>0.31490000000000001</c:v>
                </c:pt>
                <c:pt idx="1">
                  <c:v>0.51136666666666664</c:v>
                </c:pt>
                <c:pt idx="2">
                  <c:v>0.33096666666666663</c:v>
                </c:pt>
                <c:pt idx="3">
                  <c:v>0.24430000000000004</c:v>
                </c:pt>
                <c:pt idx="4">
                  <c:v>0.63139999999999996</c:v>
                </c:pt>
                <c:pt idx="5">
                  <c:v>0.4684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D2-428D-A3E4-E07151A905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85422</a:t>
            </a:r>
          </a:p>
        </c:rich>
      </c:tx>
      <c:layout>
        <c:manualLayout>
          <c:xMode val="edge"/>
          <c:yMode val="edge"/>
          <c:x val="0.28459063909028015"/>
          <c:y val="0.1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8955997739615724"/>
          <c:y val="0.23883333333333334"/>
          <c:w val="0.48773899915207308"/>
          <c:h val="0.39065026246719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R$24</c:f>
              <c:strCache>
                <c:ptCount val="1"/>
                <c:pt idx="0">
                  <c:v>Unigene008542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R$25:$R$30</c:f>
              <c:numCache>
                <c:formatCode>General</c:formatCode>
                <c:ptCount val="6"/>
                <c:pt idx="0">
                  <c:v>0.41876666666666701</c:v>
                </c:pt>
                <c:pt idx="1">
                  <c:v>2.01026666666667</c:v>
                </c:pt>
                <c:pt idx="2">
                  <c:v>0.27079999999999999</c:v>
                </c:pt>
                <c:pt idx="3">
                  <c:v>0</c:v>
                </c:pt>
                <c:pt idx="4">
                  <c:v>4.6466666666666698E-2</c:v>
                </c:pt>
                <c:pt idx="5">
                  <c:v>1.93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1A-4F3A-AA71-D1251F462E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9.3390751770096966E-2"/>
              <c:y val="0.299887795275590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56243</a:t>
            </a:r>
          </a:p>
        </c:rich>
      </c:tx>
      <c:layout>
        <c:manualLayout>
          <c:xMode val="edge"/>
          <c:yMode val="edge"/>
          <c:x val="0.31140030982333133"/>
          <c:y val="0.137073256616381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0907787314084328"/>
          <c:y val="0.25409954945261765"/>
          <c:w val="0.53365768608283992"/>
          <c:h val="0.3992595885508752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M$24</c:f>
              <c:strCache>
                <c:ptCount val="1"/>
                <c:pt idx="0">
                  <c:v>Unigene005624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M$25:$M$30</c:f>
              <c:numCache>
                <c:formatCode>General</c:formatCode>
                <c:ptCount val="6"/>
                <c:pt idx="0">
                  <c:v>0.91826666666666668</c:v>
                </c:pt>
                <c:pt idx="1">
                  <c:v>1.8989666666666667</c:v>
                </c:pt>
                <c:pt idx="2">
                  <c:v>0.67303333333333348</c:v>
                </c:pt>
                <c:pt idx="3">
                  <c:v>4.346666666666666E-2</c:v>
                </c:pt>
                <c:pt idx="4">
                  <c:v>6.8133333333333337E-2</c:v>
                </c:pt>
                <c:pt idx="5">
                  <c:v>0.3239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4F-47A4-8E75-8C11887442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4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800" dirty="0"/>
              <a:t>Unigene0076184</a:t>
            </a:r>
          </a:p>
        </c:rich>
      </c:tx>
      <c:layout>
        <c:manualLayout>
          <c:xMode val="edge"/>
          <c:yMode val="edge"/>
          <c:x val="0.32223002406119616"/>
          <c:y val="0.139402175963689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4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31947373517337641"/>
          <c:y val="0.24970414769495894"/>
          <c:w val="0.52584279653094923"/>
          <c:h val="0.406478084976328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ick!$O$24</c:f>
              <c:strCache>
                <c:ptCount val="1"/>
                <c:pt idx="0">
                  <c:v>Unigene007618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pick!$A$25:$A$30</c:f>
              <c:strCache>
                <c:ptCount val="6"/>
                <c:pt idx="0">
                  <c:v>R0min</c:v>
                </c:pt>
                <c:pt idx="1">
                  <c:v>R1min</c:v>
                </c:pt>
                <c:pt idx="2">
                  <c:v>R30min</c:v>
                </c:pt>
                <c:pt idx="3">
                  <c:v>R45min</c:v>
                </c:pt>
                <c:pt idx="4">
                  <c:v>R6h</c:v>
                </c:pt>
                <c:pt idx="5">
                  <c:v>R1d</c:v>
                </c:pt>
              </c:strCache>
            </c:strRef>
          </c:cat>
          <c:val>
            <c:numRef>
              <c:f>pick!$O$25:$O$30</c:f>
              <c:numCache>
                <c:formatCode>General</c:formatCode>
                <c:ptCount val="6"/>
                <c:pt idx="0">
                  <c:v>0.50770000000000004</c:v>
                </c:pt>
                <c:pt idx="1">
                  <c:v>0.80269999999999997</c:v>
                </c:pt>
                <c:pt idx="2">
                  <c:v>0.42746666666666699</c:v>
                </c:pt>
                <c:pt idx="3">
                  <c:v>0.115766666666667</c:v>
                </c:pt>
                <c:pt idx="4">
                  <c:v>0.103166666666667</c:v>
                </c:pt>
                <c:pt idx="5">
                  <c:v>4.493333333333329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FA-4942-B27F-E9082601FF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282914736"/>
        <c:axId val="1282915720"/>
      </c:barChart>
      <c:catAx>
        <c:axId val="1282914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5720"/>
        <c:crosses val="autoZero"/>
        <c:auto val="1"/>
        <c:lblAlgn val="ctr"/>
        <c:lblOffset val="5"/>
        <c:tickMarkSkip val="1"/>
        <c:noMultiLvlLbl val="0"/>
      </c:catAx>
      <c:valAx>
        <c:axId val="1282915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RPKM</a:t>
                </a:r>
                <a:endParaRPr lang="zh-C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282914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2EF1C2-FB5A-45B6-8E94-937912646E5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46065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13" Type="http://schemas.openxmlformats.org/officeDocument/2006/relationships/chart" Target="../charts/chart10.xml"/><Relationship Id="rId18" Type="http://schemas.openxmlformats.org/officeDocument/2006/relationships/chart" Target="../charts/chart15.xml"/><Relationship Id="rId3" Type="http://schemas.openxmlformats.org/officeDocument/2006/relationships/image" Target="../media/image1.png"/><Relationship Id="rId7" Type="http://schemas.openxmlformats.org/officeDocument/2006/relationships/chart" Target="../charts/chart4.xml"/><Relationship Id="rId12" Type="http://schemas.openxmlformats.org/officeDocument/2006/relationships/chart" Target="../charts/chart9.xml"/><Relationship Id="rId17" Type="http://schemas.openxmlformats.org/officeDocument/2006/relationships/chart" Target="../charts/chart14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3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3.xml"/><Relationship Id="rId11" Type="http://schemas.openxmlformats.org/officeDocument/2006/relationships/chart" Target="../charts/chart8.xml"/><Relationship Id="rId5" Type="http://schemas.openxmlformats.org/officeDocument/2006/relationships/chart" Target="../charts/chart2.xml"/><Relationship Id="rId15" Type="http://schemas.openxmlformats.org/officeDocument/2006/relationships/chart" Target="../charts/chart12.xml"/><Relationship Id="rId10" Type="http://schemas.openxmlformats.org/officeDocument/2006/relationships/chart" Target="../charts/chart7.xml"/><Relationship Id="rId19" Type="http://schemas.openxmlformats.org/officeDocument/2006/relationships/chart" Target="../charts/chart16.xml"/><Relationship Id="rId4" Type="http://schemas.openxmlformats.org/officeDocument/2006/relationships/chart" Target="../charts/chart1.xml"/><Relationship Id="rId9" Type="http://schemas.openxmlformats.org/officeDocument/2006/relationships/chart" Target="../charts/chart6.xml"/><Relationship Id="rId1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8B445E50-45E2-4879-8ACC-9BC823A0913C}"/>
              </a:ext>
            </a:extLst>
          </p:cNvPr>
          <p:cNvGrpSpPr/>
          <p:nvPr/>
        </p:nvGrpSpPr>
        <p:grpSpPr>
          <a:xfrm>
            <a:off x="575791" y="249899"/>
            <a:ext cx="6048341" cy="7779783"/>
            <a:chOff x="638544" y="249899"/>
            <a:chExt cx="6048341" cy="7779783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3374E789-E97B-4919-81A5-6B6FAACDAE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7773"/>
            <a:stretch/>
          </p:blipFill>
          <p:spPr>
            <a:xfrm>
              <a:off x="1192306" y="416853"/>
              <a:ext cx="4858870" cy="2156018"/>
            </a:xfrm>
            <a:prstGeom prst="rect">
              <a:avLst/>
            </a:prstGeom>
          </p:spPr>
        </p:pic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B44CF1F7-DCCF-4440-BD62-3BB040B7EDB5}"/>
                </a:ext>
              </a:extLst>
            </p:cNvPr>
            <p:cNvGrpSpPr/>
            <p:nvPr/>
          </p:nvGrpSpPr>
          <p:grpSpPr>
            <a:xfrm>
              <a:off x="838348" y="249899"/>
              <a:ext cx="5011772" cy="2546421"/>
              <a:chOff x="668018" y="285758"/>
              <a:chExt cx="5011772" cy="2546421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9935F502-5FD9-46DB-A835-F2317BAC7292}"/>
                  </a:ext>
                </a:extLst>
              </p:cNvPr>
              <p:cNvSpPr txBox="1"/>
              <p:nvPr/>
            </p:nvSpPr>
            <p:spPr>
              <a:xfrm>
                <a:off x="2257319" y="285758"/>
                <a:ext cx="2824093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nnotated coding aquaporins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4AC8D6B7-9698-48A0-B321-79CB046FDD36}"/>
                  </a:ext>
                </a:extLst>
              </p:cNvPr>
              <p:cNvSpPr txBox="1"/>
              <p:nvPr/>
            </p:nvSpPr>
            <p:spPr>
              <a:xfrm>
                <a:off x="668018" y="362622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22DE4350-2C5E-4CB3-9854-F431C4C04435}"/>
                  </a:ext>
                </a:extLst>
              </p:cNvPr>
              <p:cNvSpPr txBox="1"/>
              <p:nvPr/>
            </p:nvSpPr>
            <p:spPr>
              <a:xfrm>
                <a:off x="1737685" y="2616735"/>
                <a:ext cx="39421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     R1min              R30min            R45min                R6h    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041BDCA-3A34-408A-A3EF-01A51F665BAC}"/>
                </a:ext>
              </a:extLst>
            </p:cNvPr>
            <p:cNvSpPr txBox="1"/>
            <p:nvPr/>
          </p:nvSpPr>
          <p:spPr>
            <a:xfrm>
              <a:off x="638544" y="2700273"/>
              <a:ext cx="2792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9B728D15-8B73-4B75-B86C-35B8873C6925}"/>
                </a:ext>
              </a:extLst>
            </p:cNvPr>
            <p:cNvGrpSpPr/>
            <p:nvPr/>
          </p:nvGrpSpPr>
          <p:grpSpPr>
            <a:xfrm>
              <a:off x="651844" y="2884889"/>
              <a:ext cx="6035041" cy="5144793"/>
              <a:chOff x="592157" y="4095126"/>
              <a:chExt cx="6035041" cy="5144793"/>
            </a:xfrm>
          </p:grpSpPr>
          <p:graphicFrame>
            <p:nvGraphicFramePr>
              <p:cNvPr id="28" name="图表 27">
                <a:extLst>
                  <a:ext uri="{FF2B5EF4-FFF2-40B4-BE49-F238E27FC236}">
                    <a16:creationId xmlns:a16="http://schemas.microsoft.com/office/drawing/2014/main" id="{5720DA6A-F000-499A-AE26-08A18A48C63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97037479"/>
                  </p:ext>
                </p:extLst>
              </p:nvPr>
            </p:nvGraphicFramePr>
            <p:xfrm>
              <a:off x="3254754" y="4095126"/>
              <a:ext cx="1581138" cy="136733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30" name="图表 29">
                <a:extLst>
                  <a:ext uri="{FF2B5EF4-FFF2-40B4-BE49-F238E27FC236}">
                    <a16:creationId xmlns:a16="http://schemas.microsoft.com/office/drawing/2014/main" id="{EAB2EB9A-CA13-42DB-BBD1-F6B929F0916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00066552"/>
                  </p:ext>
                </p:extLst>
              </p:nvPr>
            </p:nvGraphicFramePr>
            <p:xfrm>
              <a:off x="4656121" y="4095126"/>
              <a:ext cx="1609722" cy="13673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10" name="组合 9">
                <a:extLst>
                  <a:ext uri="{FF2B5EF4-FFF2-40B4-BE49-F238E27FC236}">
                    <a16:creationId xmlns:a16="http://schemas.microsoft.com/office/drawing/2014/main" id="{ED902006-75BC-49C1-8B81-EFA5A084A851}"/>
                  </a:ext>
                </a:extLst>
              </p:cNvPr>
              <p:cNvGrpSpPr/>
              <p:nvPr/>
            </p:nvGrpSpPr>
            <p:grpSpPr>
              <a:xfrm>
                <a:off x="592157" y="4136095"/>
                <a:ext cx="6035041" cy="5103824"/>
                <a:chOff x="562984" y="4133859"/>
                <a:chExt cx="6035041" cy="5103824"/>
              </a:xfrm>
            </p:grpSpPr>
            <p:graphicFrame>
              <p:nvGraphicFramePr>
                <p:cNvPr id="26" name="图表 25">
                  <a:extLst>
                    <a:ext uri="{FF2B5EF4-FFF2-40B4-BE49-F238E27FC236}">
                      <a16:creationId xmlns:a16="http://schemas.microsoft.com/office/drawing/2014/main" id="{E4F32150-C25C-4B17-91FF-154A879DAC9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44509475"/>
                    </p:ext>
                  </p:extLst>
                </p:nvPr>
              </p:nvGraphicFramePr>
              <p:xfrm>
                <a:off x="646401" y="4145378"/>
                <a:ext cx="1436774" cy="131707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graphicFrame>
              <p:nvGraphicFramePr>
                <p:cNvPr id="27" name="图表 26">
                  <a:extLst>
                    <a:ext uri="{FF2B5EF4-FFF2-40B4-BE49-F238E27FC236}">
                      <a16:creationId xmlns:a16="http://schemas.microsoft.com/office/drawing/2014/main" id="{0BB7447B-0690-404B-BF16-945B16F8F04E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599985892"/>
                    </p:ext>
                  </p:extLst>
                </p:nvPr>
              </p:nvGraphicFramePr>
              <p:xfrm>
                <a:off x="2039285" y="4145377"/>
                <a:ext cx="1358340" cy="128217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graphicFrame>
              <p:nvGraphicFramePr>
                <p:cNvPr id="29" name="图表 28">
                  <a:extLst>
                    <a:ext uri="{FF2B5EF4-FFF2-40B4-BE49-F238E27FC236}">
                      <a16:creationId xmlns:a16="http://schemas.microsoft.com/office/drawing/2014/main" id="{F3890034-0772-4B3F-B2D7-85062A09A29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84604379"/>
                    </p:ext>
                  </p:extLst>
                </p:nvPr>
              </p:nvGraphicFramePr>
              <p:xfrm>
                <a:off x="608705" y="5427682"/>
                <a:ext cx="1402080" cy="120396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graphicFrame>
              <p:nvGraphicFramePr>
                <p:cNvPr id="33" name="图表 32">
                  <a:extLst>
                    <a:ext uri="{FF2B5EF4-FFF2-40B4-BE49-F238E27FC236}">
                      <a16:creationId xmlns:a16="http://schemas.microsoft.com/office/drawing/2014/main" id="{3084332D-BA45-4D6E-9CB6-F3B6412A62C2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982467824"/>
                    </p:ext>
                  </p:extLst>
                </p:nvPr>
              </p:nvGraphicFramePr>
              <p:xfrm>
                <a:off x="1877818" y="5257809"/>
                <a:ext cx="1634107" cy="145003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graphicFrame>
              <p:nvGraphicFramePr>
                <p:cNvPr id="34" name="图表 33">
                  <a:extLst>
                    <a:ext uri="{FF2B5EF4-FFF2-40B4-BE49-F238E27FC236}">
                      <a16:creationId xmlns:a16="http://schemas.microsoft.com/office/drawing/2014/main" id="{3B70ACA4-431E-4D41-8056-2A408AF4406A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628771802"/>
                    </p:ext>
                  </p:extLst>
                </p:nvPr>
              </p:nvGraphicFramePr>
              <p:xfrm>
                <a:off x="562984" y="6433522"/>
                <a:ext cx="1767841" cy="1524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"/>
                </a:graphicData>
              </a:graphic>
            </p:graphicFrame>
            <p:graphicFrame>
              <p:nvGraphicFramePr>
                <p:cNvPr id="35" name="图表 34">
                  <a:extLst>
                    <a:ext uri="{FF2B5EF4-FFF2-40B4-BE49-F238E27FC236}">
                      <a16:creationId xmlns:a16="http://schemas.microsoft.com/office/drawing/2014/main" id="{4BA0A030-4E99-4855-9EAF-53CE10DB6A28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11966786"/>
                    </p:ext>
                  </p:extLst>
                </p:nvPr>
              </p:nvGraphicFramePr>
              <p:xfrm>
                <a:off x="3253171" y="5271143"/>
                <a:ext cx="1615114" cy="148241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1"/>
                </a:graphicData>
              </a:graphic>
            </p:graphicFrame>
            <p:graphicFrame>
              <p:nvGraphicFramePr>
                <p:cNvPr id="37" name="图表 36">
                  <a:extLst>
                    <a:ext uri="{FF2B5EF4-FFF2-40B4-BE49-F238E27FC236}">
                      <a16:creationId xmlns:a16="http://schemas.microsoft.com/office/drawing/2014/main" id="{4F39FAEF-D14B-49C2-92BE-D77D7F9949F9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864464120"/>
                    </p:ext>
                  </p:extLst>
                </p:nvPr>
              </p:nvGraphicFramePr>
              <p:xfrm>
                <a:off x="4536862" y="5273049"/>
                <a:ext cx="1642063" cy="145765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2"/>
                </a:graphicData>
              </a:graphic>
            </p:graphicFrame>
            <p:graphicFrame>
              <p:nvGraphicFramePr>
                <p:cNvPr id="40" name="图表 39">
                  <a:extLst>
                    <a:ext uri="{FF2B5EF4-FFF2-40B4-BE49-F238E27FC236}">
                      <a16:creationId xmlns:a16="http://schemas.microsoft.com/office/drawing/2014/main" id="{97B0C7FA-A81F-4EE9-AFB0-DB8800C6E9F0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565995066"/>
                    </p:ext>
                  </p:extLst>
                </p:nvPr>
              </p:nvGraphicFramePr>
              <p:xfrm>
                <a:off x="1881245" y="6425902"/>
                <a:ext cx="1653540" cy="134112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3"/>
                </a:graphicData>
              </a:graphic>
            </p:graphicFrame>
            <p:sp>
              <p:nvSpPr>
                <p:cNvPr id="41" name="矩形 40">
                  <a:extLst>
                    <a:ext uri="{FF2B5EF4-FFF2-40B4-BE49-F238E27FC236}">
                      <a16:creationId xmlns:a16="http://schemas.microsoft.com/office/drawing/2014/main" id="{11F304BC-C539-4013-B6B3-F9036304B4FD}"/>
                    </a:ext>
                  </a:extLst>
                </p:cNvPr>
                <p:cNvSpPr/>
                <p:nvPr/>
              </p:nvSpPr>
              <p:spPr>
                <a:xfrm>
                  <a:off x="639186" y="4133859"/>
                  <a:ext cx="5768340" cy="4740152"/>
                </a:xfrm>
                <a:prstGeom prst="rect">
                  <a:avLst/>
                </a:prstGeom>
                <a:noFill/>
                <a:ln w="1905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n w="19050">
                      <a:solidFill>
                        <a:schemeClr val="tx1"/>
                      </a:solidFill>
                    </a:ln>
                  </a:endParaRPr>
                </a:p>
              </p:txBody>
            </p:sp>
            <p:graphicFrame>
              <p:nvGraphicFramePr>
                <p:cNvPr id="25" name="图表 24">
                  <a:extLst>
                    <a:ext uri="{FF2B5EF4-FFF2-40B4-BE49-F238E27FC236}">
                      <a16:creationId xmlns:a16="http://schemas.microsoft.com/office/drawing/2014/main" id="{EFBE163F-CDE7-4B31-A646-1E7C17D03D0B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258014377"/>
                    </p:ext>
                  </p:extLst>
                </p:nvPr>
              </p:nvGraphicFramePr>
              <p:xfrm>
                <a:off x="3252844" y="6425902"/>
                <a:ext cx="1521771" cy="137793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4"/>
                </a:graphicData>
              </a:graphic>
            </p:graphicFrame>
            <p:graphicFrame>
              <p:nvGraphicFramePr>
                <p:cNvPr id="31" name="图表 30">
                  <a:extLst>
                    <a:ext uri="{FF2B5EF4-FFF2-40B4-BE49-F238E27FC236}">
                      <a16:creationId xmlns:a16="http://schemas.microsoft.com/office/drawing/2014/main" id="{B001998C-3412-4643-A49E-E9A6A667B68A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101578552"/>
                    </p:ext>
                  </p:extLst>
                </p:nvPr>
              </p:nvGraphicFramePr>
              <p:xfrm>
                <a:off x="4563484" y="6425902"/>
                <a:ext cx="1630681" cy="14859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5"/>
                </a:graphicData>
              </a:graphic>
            </p:graphicFrame>
            <p:graphicFrame>
              <p:nvGraphicFramePr>
                <p:cNvPr id="32" name="图表 31">
                  <a:extLst>
                    <a:ext uri="{FF2B5EF4-FFF2-40B4-BE49-F238E27FC236}">
                      <a16:creationId xmlns:a16="http://schemas.microsoft.com/office/drawing/2014/main" id="{269CE0CA-DECB-4732-8E47-5AF2777373D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26256534"/>
                    </p:ext>
                  </p:extLst>
                </p:nvPr>
              </p:nvGraphicFramePr>
              <p:xfrm>
                <a:off x="568803" y="7584143"/>
                <a:ext cx="1655342" cy="16535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6"/>
                </a:graphicData>
              </a:graphic>
            </p:graphicFrame>
            <p:graphicFrame>
              <p:nvGraphicFramePr>
                <p:cNvPr id="36" name="图表 35">
                  <a:extLst>
                    <a:ext uri="{FF2B5EF4-FFF2-40B4-BE49-F238E27FC236}">
                      <a16:creationId xmlns:a16="http://schemas.microsoft.com/office/drawing/2014/main" id="{E2528302-7D5D-4F22-A436-354521EB9CA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45016932"/>
                    </p:ext>
                  </p:extLst>
                </p:nvPr>
              </p:nvGraphicFramePr>
              <p:xfrm>
                <a:off x="1878490" y="7576522"/>
                <a:ext cx="1801075" cy="163035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7"/>
                </a:graphicData>
              </a:graphic>
            </p:graphicFrame>
            <p:graphicFrame>
              <p:nvGraphicFramePr>
                <p:cNvPr id="38" name="图表 37">
                  <a:extLst>
                    <a:ext uri="{FF2B5EF4-FFF2-40B4-BE49-F238E27FC236}">
                      <a16:creationId xmlns:a16="http://schemas.microsoft.com/office/drawing/2014/main" id="{E0B706BC-A9AF-4ED3-BC77-F7772199FB0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964741002"/>
                    </p:ext>
                  </p:extLst>
                </p:nvPr>
              </p:nvGraphicFramePr>
              <p:xfrm>
                <a:off x="3254460" y="7576522"/>
                <a:ext cx="1941485" cy="166116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8"/>
                </a:graphicData>
              </a:graphic>
            </p:graphicFrame>
            <p:graphicFrame>
              <p:nvGraphicFramePr>
                <p:cNvPr id="39" name="图表 38">
                  <a:extLst>
                    <a:ext uri="{FF2B5EF4-FFF2-40B4-BE49-F238E27FC236}">
                      <a16:creationId xmlns:a16="http://schemas.microsoft.com/office/drawing/2014/main" id="{A0A8EED2-8809-4F6A-9CBB-9CA743E278EF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982709107"/>
                    </p:ext>
                  </p:extLst>
                </p:nvPr>
              </p:nvGraphicFramePr>
              <p:xfrm>
                <a:off x="4563475" y="7576522"/>
                <a:ext cx="2034550" cy="147066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9"/>
                </a:graphicData>
              </a:graphic>
            </p:graphicFrame>
            <p:sp>
              <p:nvSpPr>
                <p:cNvPr id="58" name="矩形 57">
                  <a:extLst>
                    <a:ext uri="{FF2B5EF4-FFF2-40B4-BE49-F238E27FC236}">
                      <a16:creationId xmlns:a16="http://schemas.microsoft.com/office/drawing/2014/main" id="{FA84352A-83D8-4382-B82E-E7A36577A8CA}"/>
                    </a:ext>
                  </a:extLst>
                </p:cNvPr>
                <p:cNvSpPr/>
                <p:nvPr/>
              </p:nvSpPr>
              <p:spPr>
                <a:xfrm>
                  <a:off x="723006" y="4255779"/>
                  <a:ext cx="5623560" cy="1156663"/>
                </a:xfrm>
                <a:prstGeom prst="rect">
                  <a:avLst/>
                </a:prstGeom>
                <a:noFill/>
                <a:ln w="19050" cap="flat" cmpd="sng" algn="ctr">
                  <a:solidFill>
                    <a:schemeClr val="dk1"/>
                  </a:solidFill>
                  <a:prstDash val="sys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>
                    <a:ln w="19050">
                      <a:solidFill>
                        <a:schemeClr val="tx1"/>
                      </a:solidFill>
                    </a:ln>
                  </a:endParaRPr>
                </a:p>
              </p:txBody>
            </p:sp>
            <p:sp>
              <p:nvSpPr>
                <p:cNvPr id="3" name="L 形 2">
                  <a:extLst>
                    <a:ext uri="{FF2B5EF4-FFF2-40B4-BE49-F238E27FC236}">
                      <a16:creationId xmlns:a16="http://schemas.microsoft.com/office/drawing/2014/main" id="{530D7276-830E-4481-A199-0B70FCD9010D}"/>
                    </a:ext>
                  </a:extLst>
                </p:cNvPr>
                <p:cNvSpPr/>
                <p:nvPr/>
              </p:nvSpPr>
              <p:spPr>
                <a:xfrm rot="10800000" flipH="1">
                  <a:off x="730625" y="5481022"/>
                  <a:ext cx="5615940" cy="2278380"/>
                </a:xfrm>
                <a:prstGeom prst="corner">
                  <a:avLst>
                    <a:gd name="adj1" fmla="val 48997"/>
                    <a:gd name="adj2" fmla="val 56020"/>
                  </a:avLst>
                </a:prstGeom>
                <a:noFill/>
                <a:ln w="19050" cap="flat" cmpd="sng" algn="ctr">
                  <a:solidFill>
                    <a:schemeClr val="tx1"/>
                  </a:solidFill>
                  <a:prstDash val="sys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86786BC4-76B9-41F8-93DD-5D83914EBC32}"/>
                    </a:ext>
                  </a:extLst>
                </p:cNvPr>
                <p:cNvSpPr txBox="1"/>
                <p:nvPr/>
              </p:nvSpPr>
              <p:spPr>
                <a:xfrm rot="5400000">
                  <a:off x="6053327" y="4340790"/>
                  <a:ext cx="40908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IPs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943CB942-8143-4C45-80E1-BCB902D47375}"/>
                    </a:ext>
                  </a:extLst>
                </p:cNvPr>
                <p:cNvSpPr txBox="1"/>
                <p:nvPr/>
              </p:nvSpPr>
              <p:spPr>
                <a:xfrm rot="5400000">
                  <a:off x="6066006" y="5531656"/>
                  <a:ext cx="4026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IPs</a:t>
                  </a:r>
                  <a:endPara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43" name="文本框 42">
            <a:extLst>
              <a:ext uri="{FF2B5EF4-FFF2-40B4-BE49-F238E27FC236}">
                <a16:creationId xmlns:a16="http://schemas.microsoft.com/office/drawing/2014/main" id="{E7793C2F-B5CA-4275-AB68-49E1245397BF}"/>
              </a:ext>
            </a:extLst>
          </p:cNvPr>
          <p:cNvSpPr txBox="1"/>
          <p:nvPr/>
        </p:nvSpPr>
        <p:spPr>
          <a:xfrm>
            <a:off x="553919" y="7732898"/>
            <a:ext cx="5879714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1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2. Relative expression levels of </a:t>
            </a:r>
            <a:r>
              <a:rPr lang="en-US" altLang="zh-CN" sz="11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aquaporins during rehydration in </a:t>
            </a:r>
            <a:r>
              <a:rPr lang="en-US" altLang="zh-CN" sz="11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1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1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lative expression of 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aquaporins in the rehydration progress of </a:t>
            </a:r>
            <a:r>
              <a:rPr lang="en-US" altLang="zh-CN" sz="11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1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1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of annotated coding 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ignificantly up-regulated in R1min samples. PIP: plasma membrane intrinsic protein. TIP: tonoplast membrane intrinsic protein.</a:t>
            </a:r>
            <a:endParaRPr lang="zh-CN" altLang="zh-CN" sz="1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3259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2</TotalTime>
  <Words>110</Words>
  <Application>Microsoft Office PowerPoint</Application>
  <PresentationFormat>A4 纸张(210x297 毫米)</PresentationFormat>
  <Paragraphs>4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218</cp:revision>
  <dcterms:created xsi:type="dcterms:W3CDTF">2021-01-19T12:49:28Z</dcterms:created>
  <dcterms:modified xsi:type="dcterms:W3CDTF">2023-01-10T11:15:21Z</dcterms:modified>
</cp:coreProperties>
</file>